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883" autoAdjust="0"/>
  </p:normalViewPr>
  <p:slideViewPr>
    <p:cSldViewPr>
      <p:cViewPr varScale="1">
        <p:scale>
          <a:sx n="86" d="100"/>
          <a:sy n="86" d="100"/>
        </p:scale>
        <p:origin x="1354" y="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259F8A-27F1-4958-945A-3CDB3BF54D31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9F9FFC-E9D8-4DF8-AC2F-93F2186489C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4364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9F9FFC-E9D8-4DF8-AC2F-93F2186489C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56057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0783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2182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2719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0671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4940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6676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2859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4869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9442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0041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8339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1839A-D590-4271-A4B5-037F64806A5A}" type="datetimeFigureOut">
              <a:rPr lang="de-DE" smtClean="0"/>
              <a:t>12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682470-E754-4AF4-A4FF-FE06652FCBD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1916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Rectangle 158">
            <a:extLst>
              <a:ext uri="{FF2B5EF4-FFF2-40B4-BE49-F238E27FC236}">
                <a16:creationId xmlns:a16="http://schemas.microsoft.com/office/drawing/2014/main" id="{38764E31-B56E-4585-8B94-ACDD102E57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660" y="6614151"/>
            <a:ext cx="151429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6858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alt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t>Supplemental Figure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t>S</a:t>
            </a:r>
            <a:r>
              <a:rPr kumimoji="0" lang="de-DE" alt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t>1</a:t>
            </a:r>
          </a:p>
        </p:txBody>
      </p:sp>
      <p:pic>
        <p:nvPicPr>
          <p:cNvPr id="368" name="Grafik 367">
            <a:extLst>
              <a:ext uri="{FF2B5EF4-FFF2-40B4-BE49-F238E27FC236}">
                <a16:creationId xmlns:a16="http://schemas.microsoft.com/office/drawing/2014/main" id="{36F728D0-07CF-47C9-98E7-7F4F935F231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712" y="294918"/>
            <a:ext cx="4371141" cy="4414764"/>
          </a:xfrm>
          <a:prstGeom prst="rect">
            <a:avLst/>
          </a:prstGeom>
        </p:spPr>
      </p:pic>
      <p:sp>
        <p:nvSpPr>
          <p:cNvPr id="2" name="Rechteck 1">
            <a:extLst>
              <a:ext uri="{FF2B5EF4-FFF2-40B4-BE49-F238E27FC236}">
                <a16:creationId xmlns:a16="http://schemas.microsoft.com/office/drawing/2014/main" id="{79C3181E-4557-4171-9AE1-E171D0BEEC07}"/>
              </a:ext>
            </a:extLst>
          </p:cNvPr>
          <p:cNvSpPr/>
          <p:nvPr/>
        </p:nvSpPr>
        <p:spPr>
          <a:xfrm>
            <a:off x="1475656" y="4821540"/>
            <a:ext cx="6120680" cy="12311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. shRNA-mediated knockdown of DICER1 and/or DROSHA in HUVEC reduces DICER1 and/or DROSHA mRNA in these cell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RNA-mediated knockdown of either DICER1 (red column) or DROSHA (blue column) or both (black columns) significantly (DICER1 knockdown alone) or non-significantly reduces the respective mRNA expression in HUVEC as evidenced by real-time PCR detection (n=3 biological replicates from independent transductions).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207823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Larissa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G Benndorf</dc:creator>
  <cp:lastModifiedBy>MDPI</cp:lastModifiedBy>
  <cp:revision>114</cp:revision>
  <dcterms:created xsi:type="dcterms:W3CDTF">2020-04-09T07:54:33Z</dcterms:created>
  <dcterms:modified xsi:type="dcterms:W3CDTF">2021-09-12T10:07:38Z</dcterms:modified>
</cp:coreProperties>
</file>